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39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759C98-31E3-44D8-AB6F-12AFB416285B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F68F36-8BE6-44A8-AD57-70266D0C60C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693005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F68F36-8BE6-44A8-AD57-70266D0C60C1}" type="slidenum">
              <a:rPr lang="tr-TR" smtClean="0"/>
              <a:t>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9251180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592E5B0-8605-239F-1480-00AC220CBC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532A5990-20A6-822A-3E94-DFA74F6155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B94A28C-EAB5-5BDF-FBC2-54A353059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C4D2B241-1459-8197-F619-3F4D21ECB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E0B7CBE-CE55-63A7-772F-4837318BB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264374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E684EE2E-F4A7-7D44-6C2F-883E62989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D9AD859D-B283-5E72-BE33-C9C0A64AE1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CD5FDC3-0DAE-B107-9B50-ED0DD70BD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4CC894BA-C47F-CA0F-C0AE-1F8BA5B35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43CE458-D4B3-6015-73D1-ED7F6B657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00739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C8ACEA4E-45F9-8A92-62EE-F6EC2D4275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A6FD70E6-97AC-3801-5008-8926E8FA93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CC97617C-5839-EB03-237B-202356603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C956CC44-A860-5AFF-A92D-ABD7CC10D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57FE5162-E0AA-6945-EDC4-A2256AC4C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144573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5604B168-5C00-3533-6CEF-6D16C49B4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18E76B98-D4F7-5D8F-179B-BDAD990BF3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548AED9B-E603-872B-A479-4673C0FCD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4E3153D-9AF3-E263-93FB-1F9F2C510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9E4FE8FB-C339-ADFB-85FB-D8FAC3935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843782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C6A5B5A4-F98C-91DA-FCE3-5BA01DCB8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08F34BA8-72A2-AD21-0867-A3EB779D6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3FA1AE29-A4B2-31E9-AF64-FB4B3FA18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3A71F3EF-C66E-3648-9A0B-22710DE37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0AAFF4B0-2FFD-CFB9-0785-E3BCAD981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73652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01ABDB0-77FB-AA63-7619-18C86A06BF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389495F4-0584-19A9-9BBF-7F97F3384C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A9F955BC-6D47-64DB-3BAF-311CC0B888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A055B0EA-4D04-4D2F-6ADA-0E838D520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351B5915-FB2E-AFCE-2FC5-6BFF2276F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D5F1FD07-0724-D5ED-6832-9BCDB228D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37808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CCB60901-0002-8084-398A-956CF0C40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807BD046-6157-52A8-115C-97B4C40794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A17CFC00-FA02-311D-18A9-23BEBA1564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B83F533A-4046-5DF5-AE39-71A95430E8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577EAD8A-0CAF-6E91-E46D-20B27458AD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DFCCCA10-34DD-6C18-6E95-24F2DC224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BFC5CFAF-BEA6-B851-0C16-D60AAE419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6FB64A2C-518D-5DCE-659B-7EE0A9F1C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274719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D546E0D-0F61-EF13-6A53-24B409176E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E43902E9-BA2D-B937-C1EC-1B64DEE90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FB56D449-D8FC-6CEC-AD73-2D8A7712C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19949429-FF64-906F-6D8B-86034952A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02057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F92A2C76-DECA-A3C7-050B-1505E18B9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EE38CE5B-2302-C1F7-72E5-6D1B86BF4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50751955-6D44-556B-11EC-54ABCF706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054568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C90BBBA-027B-02C7-C181-7A683F22F0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21A082CA-F841-D46D-DD0B-D7B1125235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26C72D05-B412-3B0D-DCD6-F17E9CE8E0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E0683B5-E86B-32E7-07F1-811EF5713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915EB20D-46AE-4DF6-E05A-B6CCD51C7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DE0EA900-A9E9-678B-59C7-1AC9C9A33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241550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E485F3FA-A0F7-8592-101A-6D5B9A31EB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C510458E-C381-89EF-7230-06FE5D5965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985754BF-217E-AC79-6B8C-B36ACC5E5B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25C45764-29D2-D21A-460F-3AA6BCCD3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5AD57E98-56DF-0B94-04FC-A98970884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427F7F09-78E4-4006-C9AB-1B104B885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43864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29E8BE14-6697-6A76-2EF8-2A230714C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CA62E388-3FF6-C5AB-7357-E2658F6DB2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E16DB2C5-2877-05C3-04FB-022EBF0C3C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B90FC-8A3B-4911-ABF1-102343268269}" type="datetimeFigureOut">
              <a:rPr lang="tr-TR" smtClean="0"/>
              <a:t>6.10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C16EBC5-181E-03CB-1EE2-7BC5E53C87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099054A-281E-2A55-7A5D-066A4817DD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AEF4F9-A855-4836-A102-4C35A5A54441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64596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 1">
            <a:extLst>
              <a:ext uri="{FF2B5EF4-FFF2-40B4-BE49-F238E27FC236}">
                <a16:creationId xmlns:a16="http://schemas.microsoft.com/office/drawing/2014/main" id="{6F7946D9-5348-DF56-AEDE-576FB2E66F62}"/>
              </a:ext>
            </a:extLst>
          </p:cNvPr>
          <p:cNvGrpSpPr/>
          <p:nvPr/>
        </p:nvGrpSpPr>
        <p:grpSpPr>
          <a:xfrm>
            <a:off x="905281" y="192881"/>
            <a:ext cx="11059830" cy="6472238"/>
            <a:chOff x="1039393" y="0"/>
            <a:chExt cx="11059830" cy="6472238"/>
          </a:xfrm>
        </p:grpSpPr>
        <p:pic>
          <p:nvPicPr>
            <p:cNvPr id="4" name="image132.png">
              <a:extLst>
                <a:ext uri="{FF2B5EF4-FFF2-40B4-BE49-F238E27FC236}">
                  <a16:creationId xmlns:a16="http://schemas.microsoft.com/office/drawing/2014/main" id="{BCC93636-342F-1C71-9B99-9CDFA08F9F06}"/>
                </a:ext>
              </a:extLst>
            </p:cNvPr>
            <p:cNvPicPr/>
            <p:nvPr/>
          </p:nvPicPr>
          <p:blipFill rotWithShape="1">
            <a:blip r:embed="rId3"/>
            <a:srcRect l="-2" r="38602" b="4859"/>
            <a:stretch/>
          </p:blipFill>
          <p:spPr>
            <a:xfrm>
              <a:off x="2214563" y="342899"/>
              <a:ext cx="3000375" cy="6129339"/>
            </a:xfrm>
            <a:prstGeom prst="rect">
              <a:avLst/>
            </a:prstGeom>
            <a:ln/>
          </p:spPr>
        </p:pic>
        <p:pic>
          <p:nvPicPr>
            <p:cNvPr id="8" name="image138.png">
              <a:extLst>
                <a:ext uri="{FF2B5EF4-FFF2-40B4-BE49-F238E27FC236}">
                  <a16:creationId xmlns:a16="http://schemas.microsoft.com/office/drawing/2014/main" id="{153E5C77-FCBF-6979-65CE-51422F798B56}"/>
                </a:ext>
              </a:extLst>
            </p:cNvPr>
            <p:cNvPicPr/>
            <p:nvPr/>
          </p:nvPicPr>
          <p:blipFill rotWithShape="1">
            <a:blip r:embed="rId4"/>
            <a:srcRect r="38766" b="4724"/>
            <a:stretch/>
          </p:blipFill>
          <p:spPr>
            <a:xfrm>
              <a:off x="5719763" y="342899"/>
              <a:ext cx="3000375" cy="6129339"/>
            </a:xfrm>
            <a:prstGeom prst="rect">
              <a:avLst/>
            </a:prstGeom>
            <a:ln/>
          </p:spPr>
        </p:pic>
        <p:sp>
          <p:nvSpPr>
            <p:cNvPr id="9" name="Metin kutusu 8">
              <a:extLst>
                <a:ext uri="{FF2B5EF4-FFF2-40B4-BE49-F238E27FC236}">
                  <a16:creationId xmlns:a16="http://schemas.microsoft.com/office/drawing/2014/main" id="{0969340C-0C6D-09A4-F189-E2A0A30196FC}"/>
                </a:ext>
              </a:extLst>
            </p:cNvPr>
            <p:cNvSpPr txBox="1"/>
            <p:nvPr/>
          </p:nvSpPr>
          <p:spPr>
            <a:xfrm>
              <a:off x="2162174" y="0"/>
              <a:ext cx="30861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rizontal(Maximum – Minimum</a:t>
              </a:r>
              <a:r>
                <a:rPr lang="tr-TR" sz="1600" dirty="0"/>
                <a:t>)</a:t>
              </a:r>
            </a:p>
          </p:txBody>
        </p:sp>
        <p:sp>
          <p:nvSpPr>
            <p:cNvPr id="10" name="Metin kutusu 9">
              <a:extLst>
                <a:ext uri="{FF2B5EF4-FFF2-40B4-BE49-F238E27FC236}">
                  <a16:creationId xmlns:a16="http://schemas.microsoft.com/office/drawing/2014/main" id="{E9261B2C-7E8E-B21D-D70D-07E66F6692BC}"/>
                </a:ext>
              </a:extLst>
            </p:cNvPr>
            <p:cNvSpPr txBox="1"/>
            <p:nvPr/>
          </p:nvSpPr>
          <p:spPr>
            <a:xfrm>
              <a:off x="5719763" y="0"/>
              <a:ext cx="2819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lique(Maximum - Minimum)</a:t>
              </a:r>
            </a:p>
          </p:txBody>
        </p:sp>
        <p:sp>
          <p:nvSpPr>
            <p:cNvPr id="11" name="Metin kutusu 10">
              <a:extLst>
                <a:ext uri="{FF2B5EF4-FFF2-40B4-BE49-F238E27FC236}">
                  <a16:creationId xmlns:a16="http://schemas.microsoft.com/office/drawing/2014/main" id="{7BDC4281-79F7-3BE4-007F-EA231B92ABCC}"/>
                </a:ext>
              </a:extLst>
            </p:cNvPr>
            <p:cNvSpPr txBox="1"/>
            <p:nvPr/>
          </p:nvSpPr>
          <p:spPr>
            <a:xfrm>
              <a:off x="1039393" y="1237954"/>
              <a:ext cx="141550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2</a:t>
              </a:r>
            </a:p>
          </p:txBody>
        </p:sp>
        <p:sp>
          <p:nvSpPr>
            <p:cNvPr id="12" name="Metin kutusu 11">
              <a:extLst>
                <a:ext uri="{FF2B5EF4-FFF2-40B4-BE49-F238E27FC236}">
                  <a16:creationId xmlns:a16="http://schemas.microsoft.com/office/drawing/2014/main" id="{6E434827-DD98-C366-7038-55ECD070FCE3}"/>
                </a:ext>
              </a:extLst>
            </p:cNvPr>
            <p:cNvSpPr txBox="1"/>
            <p:nvPr/>
          </p:nvSpPr>
          <p:spPr>
            <a:xfrm>
              <a:off x="1077216" y="274571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1</a:t>
              </a:r>
            </a:p>
          </p:txBody>
        </p:sp>
        <p:sp>
          <p:nvSpPr>
            <p:cNvPr id="13" name="Metin kutusu 12">
              <a:extLst>
                <a:ext uri="{FF2B5EF4-FFF2-40B4-BE49-F238E27FC236}">
                  <a16:creationId xmlns:a16="http://schemas.microsoft.com/office/drawing/2014/main" id="{5BE8740F-7A8E-0600-EC67-C1E241EDC829}"/>
                </a:ext>
              </a:extLst>
            </p:cNvPr>
            <p:cNvSpPr txBox="1"/>
            <p:nvPr/>
          </p:nvSpPr>
          <p:spPr>
            <a:xfrm>
              <a:off x="1043879" y="2090146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3</a:t>
              </a:r>
            </a:p>
          </p:txBody>
        </p:sp>
        <p:sp>
          <p:nvSpPr>
            <p:cNvPr id="14" name="Metin kutusu 13">
              <a:extLst>
                <a:ext uri="{FF2B5EF4-FFF2-40B4-BE49-F238E27FC236}">
                  <a16:creationId xmlns:a16="http://schemas.microsoft.com/office/drawing/2014/main" id="{BB3177B5-6766-00FC-4F49-E933145C1FF0}"/>
                </a:ext>
              </a:extLst>
            </p:cNvPr>
            <p:cNvSpPr txBox="1"/>
            <p:nvPr/>
          </p:nvSpPr>
          <p:spPr>
            <a:xfrm>
              <a:off x="1043879" y="2942338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4</a:t>
              </a:r>
            </a:p>
          </p:txBody>
        </p:sp>
        <p:sp>
          <p:nvSpPr>
            <p:cNvPr id="15" name="Metin kutusu 14">
              <a:extLst>
                <a:ext uri="{FF2B5EF4-FFF2-40B4-BE49-F238E27FC236}">
                  <a16:creationId xmlns:a16="http://schemas.microsoft.com/office/drawing/2014/main" id="{A4B17791-E1D1-8FEE-6B3C-0E6ADF5D8A7B}"/>
                </a:ext>
              </a:extLst>
            </p:cNvPr>
            <p:cNvSpPr txBox="1"/>
            <p:nvPr/>
          </p:nvSpPr>
          <p:spPr>
            <a:xfrm>
              <a:off x="1043219" y="3794530"/>
              <a:ext cx="1332985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5</a:t>
              </a:r>
            </a:p>
          </p:txBody>
        </p:sp>
        <p:sp>
          <p:nvSpPr>
            <p:cNvPr id="16" name="Metin kutusu 15">
              <a:extLst>
                <a:ext uri="{FF2B5EF4-FFF2-40B4-BE49-F238E27FC236}">
                  <a16:creationId xmlns:a16="http://schemas.microsoft.com/office/drawing/2014/main" id="{AA0368AB-7142-F7C3-EA48-9474EB84A88F}"/>
                </a:ext>
              </a:extLst>
            </p:cNvPr>
            <p:cNvSpPr txBox="1"/>
            <p:nvPr/>
          </p:nvSpPr>
          <p:spPr>
            <a:xfrm>
              <a:off x="1043879" y="4646722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6</a:t>
              </a:r>
            </a:p>
          </p:txBody>
        </p:sp>
        <p:sp>
          <p:nvSpPr>
            <p:cNvPr id="17" name="Metin kutusu 16">
              <a:extLst>
                <a:ext uri="{FF2B5EF4-FFF2-40B4-BE49-F238E27FC236}">
                  <a16:creationId xmlns:a16="http://schemas.microsoft.com/office/drawing/2014/main" id="{9A1A6432-51C6-C43A-621C-F87106C394D7}"/>
                </a:ext>
              </a:extLst>
            </p:cNvPr>
            <p:cNvSpPr txBox="1"/>
            <p:nvPr/>
          </p:nvSpPr>
          <p:spPr>
            <a:xfrm>
              <a:off x="1043879" y="5498915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7</a:t>
              </a:r>
            </a:p>
          </p:txBody>
        </p:sp>
        <p:grpSp>
          <p:nvGrpSpPr>
            <p:cNvPr id="21" name="Grup 20">
              <a:extLst>
                <a:ext uri="{FF2B5EF4-FFF2-40B4-BE49-F238E27FC236}">
                  <a16:creationId xmlns:a16="http://schemas.microsoft.com/office/drawing/2014/main" id="{0DAE55C2-5416-8FFD-D687-2FC30FE10A4E}"/>
                </a:ext>
              </a:extLst>
            </p:cNvPr>
            <p:cNvGrpSpPr/>
            <p:nvPr/>
          </p:nvGrpSpPr>
          <p:grpSpPr>
            <a:xfrm>
              <a:off x="9180881" y="957263"/>
              <a:ext cx="2918342" cy="5032965"/>
              <a:chOff x="6141353" y="174064"/>
              <a:chExt cx="4049068" cy="6176289"/>
            </a:xfrm>
          </p:grpSpPr>
          <p:pic>
            <p:nvPicPr>
              <p:cNvPr id="22" name="Resim 21">
                <a:extLst>
                  <a:ext uri="{FF2B5EF4-FFF2-40B4-BE49-F238E27FC236}">
                    <a16:creationId xmlns:a16="http://schemas.microsoft.com/office/drawing/2014/main" id="{53435E4C-7357-7A8D-E4F7-0213FEC4E5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578" t="68402"/>
              <a:stretch/>
            </p:blipFill>
            <p:spPr>
              <a:xfrm>
                <a:off x="7281709" y="174064"/>
                <a:ext cx="1626680" cy="2496851"/>
              </a:xfrm>
              <a:prstGeom prst="rect">
                <a:avLst/>
              </a:prstGeom>
            </p:spPr>
          </p:pic>
          <p:grpSp>
            <p:nvGrpSpPr>
              <p:cNvPr id="23" name="Grup 22">
                <a:extLst>
                  <a:ext uri="{FF2B5EF4-FFF2-40B4-BE49-F238E27FC236}">
                    <a16:creationId xmlns:a16="http://schemas.microsoft.com/office/drawing/2014/main" id="{211A4B2F-653A-68F8-627D-9CF3AD782DC5}"/>
                  </a:ext>
                </a:extLst>
              </p:cNvPr>
              <p:cNvGrpSpPr/>
              <p:nvPr/>
            </p:nvGrpSpPr>
            <p:grpSpPr>
              <a:xfrm>
                <a:off x="6141353" y="2743201"/>
                <a:ext cx="4049068" cy="3607152"/>
                <a:chOff x="5450966" y="1732142"/>
                <a:chExt cx="4049068" cy="3607152"/>
              </a:xfrm>
            </p:grpSpPr>
            <p:grpSp>
              <p:nvGrpSpPr>
                <p:cNvPr id="24" name="Grup 23">
                  <a:extLst>
                    <a:ext uri="{FF2B5EF4-FFF2-40B4-BE49-F238E27FC236}">
                      <a16:creationId xmlns:a16="http://schemas.microsoft.com/office/drawing/2014/main" id="{452AA01D-53D7-BA20-7144-530042FD1798}"/>
                    </a:ext>
                  </a:extLst>
                </p:cNvPr>
                <p:cNvGrpSpPr/>
                <p:nvPr/>
              </p:nvGrpSpPr>
              <p:grpSpPr>
                <a:xfrm>
                  <a:off x="5450966" y="1732143"/>
                  <a:ext cx="2020646" cy="3597955"/>
                  <a:chOff x="5450966" y="1732143"/>
                  <a:chExt cx="2020646" cy="3597955"/>
                </a:xfrm>
              </p:grpSpPr>
              <p:pic>
                <p:nvPicPr>
                  <p:cNvPr id="28" name="Resim 27">
                    <a:extLst>
                      <a:ext uri="{FF2B5EF4-FFF2-40B4-BE49-F238E27FC236}">
                        <a16:creationId xmlns:a16="http://schemas.microsoft.com/office/drawing/2014/main" id="{721BA2BB-33E2-7CAD-9776-BF827C156BA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90176" b="68563"/>
                  <a:stretch/>
                </p:blipFill>
                <p:spPr>
                  <a:xfrm>
                    <a:off x="5450966" y="1732143"/>
                    <a:ext cx="2020646" cy="359795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29" name="Metin kutusu 28">
                    <a:extLst>
                      <a:ext uri="{FF2B5EF4-FFF2-40B4-BE49-F238E27FC236}">
                        <a16:creationId xmlns:a16="http://schemas.microsoft.com/office/drawing/2014/main" id="{D6E00CE0-B173-05CF-097A-40C83BD8DA99}"/>
                      </a:ext>
                    </a:extLst>
                  </p:cNvPr>
                  <p:cNvSpPr txBox="1"/>
                  <p:nvPr/>
                </p:nvSpPr>
                <p:spPr>
                  <a:xfrm>
                    <a:off x="6728504" y="4755997"/>
                    <a:ext cx="355587" cy="4616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tr-TR" sz="2400" dirty="0"/>
                      <a:t>A</a:t>
                    </a:r>
                  </a:p>
                </p:txBody>
              </p:sp>
            </p:grpSp>
            <p:grpSp>
              <p:nvGrpSpPr>
                <p:cNvPr id="25" name="Grup 24">
                  <a:extLst>
                    <a:ext uri="{FF2B5EF4-FFF2-40B4-BE49-F238E27FC236}">
                      <a16:creationId xmlns:a16="http://schemas.microsoft.com/office/drawing/2014/main" id="{4CC67508-6703-4C32-2A70-67DD59F28054}"/>
                    </a:ext>
                  </a:extLst>
                </p:cNvPr>
                <p:cNvGrpSpPr/>
                <p:nvPr/>
              </p:nvGrpSpPr>
              <p:grpSpPr>
                <a:xfrm>
                  <a:off x="7482450" y="1732142"/>
                  <a:ext cx="2017584" cy="3607152"/>
                  <a:chOff x="7482450" y="1732142"/>
                  <a:chExt cx="2017584" cy="3607152"/>
                </a:xfrm>
              </p:grpSpPr>
              <p:pic>
                <p:nvPicPr>
                  <p:cNvPr id="26" name="Resim 25">
                    <a:extLst>
                      <a:ext uri="{FF2B5EF4-FFF2-40B4-BE49-F238E27FC236}">
                        <a16:creationId xmlns:a16="http://schemas.microsoft.com/office/drawing/2014/main" id="{3430738C-671B-BB36-F55A-3BE11E1647A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" r="90552" b="69065"/>
                  <a:stretch/>
                </p:blipFill>
                <p:spPr>
                  <a:xfrm>
                    <a:off x="7482450" y="1732142"/>
                    <a:ext cx="2017584" cy="360715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27" name="Metin kutusu 26">
                    <a:extLst>
                      <a:ext uri="{FF2B5EF4-FFF2-40B4-BE49-F238E27FC236}">
                        <a16:creationId xmlns:a16="http://schemas.microsoft.com/office/drawing/2014/main" id="{08331D7E-1E4B-106F-8AF6-EE08C43AD7C0}"/>
                      </a:ext>
                    </a:extLst>
                  </p:cNvPr>
                  <p:cNvSpPr txBox="1"/>
                  <p:nvPr/>
                </p:nvSpPr>
                <p:spPr>
                  <a:xfrm>
                    <a:off x="8893824" y="4755997"/>
                    <a:ext cx="382698" cy="4616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tr-TR" sz="2400" dirty="0"/>
                      <a:t>B</a:t>
                    </a: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1135800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9</Words>
  <Application>Microsoft Office PowerPoint</Application>
  <PresentationFormat>Geniş ekran</PresentationFormat>
  <Paragraphs>12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4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Beril Demircan</dc:creator>
  <cp:lastModifiedBy>Beril Demircan</cp:lastModifiedBy>
  <cp:revision>8</cp:revision>
  <dcterms:created xsi:type="dcterms:W3CDTF">2023-05-17T13:44:32Z</dcterms:created>
  <dcterms:modified xsi:type="dcterms:W3CDTF">2023-10-06T07:41:43Z</dcterms:modified>
</cp:coreProperties>
</file>